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D51B34"/>
    <a:srgbClr val="780A58"/>
    <a:srgbClr val="18FF9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-80" y="216"/>
      </p:cViewPr>
      <p:guideLst>
        <p:guide orient="horz" pos="1044"/>
        <p:guide pos="40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691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85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59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261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72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442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4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0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9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799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781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3FB6D-F26F-1B49-9506-F91B9F5FF704}" type="datetimeFigureOut">
              <a:rPr lang="en-US" smtClean="0"/>
              <a:t>12/31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C229C-F5BF-844B-833B-74CF2CBD10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051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6" name="Straight Arrow Connector 25"/>
          <p:cNvCxnSpPr/>
          <p:nvPr/>
        </p:nvCxnSpPr>
        <p:spPr>
          <a:xfrm>
            <a:off x="427567" y="2579702"/>
            <a:ext cx="4504266" cy="0"/>
          </a:xfrm>
          <a:prstGeom prst="straightConnector1">
            <a:avLst/>
          </a:prstGeom>
          <a:ln w="63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864097" y="2438652"/>
            <a:ext cx="4981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CD47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133579" y="905595"/>
            <a:ext cx="11175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% of maximum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332920" y="266424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/>
                <a:cs typeface="Times New Roman"/>
              </a:rPr>
              <a:t>Jurkat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564678" y="276945"/>
            <a:ext cx="5409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JINB8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5699110" y="264685"/>
            <a:ext cx="1181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/>
                <a:cs typeface="Times New Roman"/>
              </a:rPr>
              <a:t>JINB8 + CD47-V5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cxnSp>
        <p:nvCxnSpPr>
          <p:cNvPr id="94" name="Straight Arrow Connector 93"/>
          <p:cNvCxnSpPr/>
          <p:nvPr/>
        </p:nvCxnSpPr>
        <p:spPr>
          <a:xfrm flipH="1" flipV="1">
            <a:off x="427567" y="1524000"/>
            <a:ext cx="1758" cy="1055702"/>
          </a:xfrm>
          <a:prstGeom prst="straightConnector1">
            <a:avLst/>
          </a:prstGeom>
          <a:ln w="6350" cmpd="sng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1982" y="530784"/>
            <a:ext cx="2136971" cy="864523"/>
          </a:xfrm>
          <a:prstGeom prst="rect">
            <a:avLst/>
          </a:prstGeom>
        </p:spPr>
      </p:pic>
      <p:grpSp>
        <p:nvGrpSpPr>
          <p:cNvPr id="93" name="Group 92"/>
          <p:cNvGrpSpPr/>
          <p:nvPr/>
        </p:nvGrpSpPr>
        <p:grpSpPr>
          <a:xfrm>
            <a:off x="1753144" y="505187"/>
            <a:ext cx="994550" cy="831983"/>
            <a:chOff x="5567951" y="1985088"/>
            <a:chExt cx="994550" cy="831983"/>
          </a:xfrm>
        </p:grpSpPr>
        <p:cxnSp>
          <p:nvCxnSpPr>
            <p:cNvPr id="95" name="Straight Connector 94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7997" y="536950"/>
            <a:ext cx="2135153" cy="862414"/>
          </a:xfrm>
          <a:prstGeom prst="rect">
            <a:avLst/>
          </a:prstGeom>
        </p:spPr>
      </p:pic>
      <p:grpSp>
        <p:nvGrpSpPr>
          <p:cNvPr id="152" name="Group 151"/>
          <p:cNvGrpSpPr/>
          <p:nvPr/>
        </p:nvGrpSpPr>
        <p:grpSpPr>
          <a:xfrm>
            <a:off x="3943894" y="498837"/>
            <a:ext cx="994550" cy="831983"/>
            <a:chOff x="5567951" y="1985088"/>
            <a:chExt cx="994550" cy="831983"/>
          </a:xfrm>
        </p:grpSpPr>
        <p:cxnSp>
          <p:nvCxnSpPr>
            <p:cNvPr id="153" name="Straight Connector 152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31668" y="530600"/>
            <a:ext cx="2337969" cy="868580"/>
          </a:xfrm>
          <a:prstGeom prst="rect">
            <a:avLst/>
          </a:prstGeom>
        </p:spPr>
      </p:pic>
      <p:grpSp>
        <p:nvGrpSpPr>
          <p:cNvPr id="163" name="Group 162"/>
          <p:cNvGrpSpPr/>
          <p:nvPr/>
        </p:nvGrpSpPr>
        <p:grpSpPr>
          <a:xfrm>
            <a:off x="6331494" y="505187"/>
            <a:ext cx="994550" cy="831983"/>
            <a:chOff x="5567951" y="1985088"/>
            <a:chExt cx="994550" cy="831983"/>
          </a:xfrm>
        </p:grpSpPr>
        <p:cxnSp>
          <p:nvCxnSpPr>
            <p:cNvPr id="164" name="Straight Connector 163"/>
            <p:cNvCxnSpPr/>
            <p:nvPr/>
          </p:nvCxnSpPr>
          <p:spPr>
            <a:xfrm>
              <a:off x="5567951" y="2133600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/>
            <p:nvPr/>
          </p:nvCxnSpPr>
          <p:spPr>
            <a:xfrm>
              <a:off x="5567951" y="2269067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5576412" y="2421467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5584873" y="2573867"/>
              <a:ext cx="23706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167"/>
            <p:cNvCxnSpPr/>
            <p:nvPr/>
          </p:nvCxnSpPr>
          <p:spPr>
            <a:xfrm>
              <a:off x="5593334" y="2726267"/>
              <a:ext cx="237066" cy="0"/>
            </a:xfrm>
            <a:prstGeom prst="line">
              <a:avLst/>
            </a:prstGeom>
            <a:ln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168"/>
            <p:cNvSpPr txBox="1"/>
            <p:nvPr/>
          </p:nvSpPr>
          <p:spPr>
            <a:xfrm>
              <a:off x="5745730" y="1985088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5745724" y="2137488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5745724" y="2289894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5762658" y="2442300"/>
              <a:ext cx="7998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5762658" y="2586239"/>
              <a:ext cx="4540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TSP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9899" y="1525593"/>
            <a:ext cx="2135075" cy="864372"/>
          </a:xfrm>
          <a:prstGeom prst="rect">
            <a:avLst/>
          </a:prstGeom>
        </p:spPr>
      </p:pic>
      <p:grpSp>
        <p:nvGrpSpPr>
          <p:cNvPr id="174" name="Group 173"/>
          <p:cNvGrpSpPr/>
          <p:nvPr/>
        </p:nvGrpSpPr>
        <p:grpSpPr>
          <a:xfrm>
            <a:off x="1591105" y="1473634"/>
            <a:ext cx="1176128" cy="831983"/>
            <a:chOff x="4800477" y="2925645"/>
            <a:chExt cx="1176128" cy="831983"/>
          </a:xfrm>
        </p:grpSpPr>
        <p:cxnSp>
          <p:nvCxnSpPr>
            <p:cNvPr id="175" name="Straight Connector 174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6" name="Straight Connector 175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Straight Connector 176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Straight Connector 178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TextBox 179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54825" y="1533027"/>
            <a:ext cx="2134675" cy="863601"/>
          </a:xfrm>
          <a:prstGeom prst="rect">
            <a:avLst/>
          </a:prstGeom>
        </p:spPr>
      </p:pic>
      <p:grpSp>
        <p:nvGrpSpPr>
          <p:cNvPr id="185" name="Group 184"/>
          <p:cNvGrpSpPr/>
          <p:nvPr/>
        </p:nvGrpSpPr>
        <p:grpSpPr>
          <a:xfrm>
            <a:off x="3776869" y="1493587"/>
            <a:ext cx="1176128" cy="831983"/>
            <a:chOff x="4800477" y="2925645"/>
            <a:chExt cx="1176128" cy="831983"/>
          </a:xfrm>
        </p:grpSpPr>
        <p:cxnSp>
          <p:nvCxnSpPr>
            <p:cNvPr id="186" name="Straight Connector 185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87" name="Straight Connector 186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Connector 187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Straight Connector 188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TextBox 190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31190" y="1524001"/>
            <a:ext cx="2333210" cy="872627"/>
          </a:xfrm>
          <a:prstGeom prst="rect">
            <a:avLst/>
          </a:prstGeom>
        </p:spPr>
      </p:pic>
      <p:grpSp>
        <p:nvGrpSpPr>
          <p:cNvPr id="196" name="Group 195"/>
          <p:cNvGrpSpPr/>
          <p:nvPr/>
        </p:nvGrpSpPr>
        <p:grpSpPr>
          <a:xfrm>
            <a:off x="6158122" y="1501277"/>
            <a:ext cx="1176128" cy="831983"/>
            <a:chOff x="4800477" y="2925645"/>
            <a:chExt cx="1176128" cy="831983"/>
          </a:xfrm>
        </p:grpSpPr>
        <p:cxnSp>
          <p:nvCxnSpPr>
            <p:cNvPr id="197" name="Straight Connector 196"/>
            <p:cNvCxnSpPr/>
            <p:nvPr/>
          </p:nvCxnSpPr>
          <p:spPr>
            <a:xfrm>
              <a:off x="4800477" y="3074157"/>
              <a:ext cx="237066" cy="0"/>
            </a:xfrm>
            <a:prstGeom prst="line">
              <a:avLst/>
            </a:prstGeom>
            <a:ln w="76200" cmpd="sng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8" name="Straight Connector 197"/>
            <p:cNvCxnSpPr/>
            <p:nvPr/>
          </p:nvCxnSpPr>
          <p:spPr>
            <a:xfrm>
              <a:off x="4800477" y="3209624"/>
              <a:ext cx="237066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Connector 198"/>
            <p:cNvCxnSpPr/>
            <p:nvPr/>
          </p:nvCxnSpPr>
          <p:spPr>
            <a:xfrm>
              <a:off x="4808938" y="3362024"/>
              <a:ext cx="237066" cy="0"/>
            </a:xfrm>
            <a:prstGeom prst="line">
              <a:avLst/>
            </a:prstGeom>
            <a:ln>
              <a:solidFill>
                <a:srgbClr val="18FF9E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Straight Connector 199"/>
            <p:cNvCxnSpPr/>
            <p:nvPr/>
          </p:nvCxnSpPr>
          <p:spPr>
            <a:xfrm>
              <a:off x="4817399" y="3514424"/>
              <a:ext cx="237066" cy="0"/>
            </a:xfrm>
            <a:prstGeom prst="line">
              <a:avLst/>
            </a:prstGeom>
            <a:ln>
              <a:solidFill>
                <a:srgbClr val="780A58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/>
            <p:cNvCxnSpPr/>
            <p:nvPr/>
          </p:nvCxnSpPr>
          <p:spPr>
            <a:xfrm>
              <a:off x="4825860" y="3666824"/>
              <a:ext cx="237066" cy="0"/>
            </a:xfrm>
            <a:prstGeom prst="line">
              <a:avLst/>
            </a:prstGeom>
            <a:ln>
              <a:solidFill>
                <a:srgbClr val="D51B34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TextBox 201"/>
            <p:cNvSpPr txBox="1"/>
            <p:nvPr/>
          </p:nvSpPr>
          <p:spPr>
            <a:xfrm>
              <a:off x="4978256" y="2925645"/>
              <a:ext cx="54376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err="1" smtClean="0">
                  <a:latin typeface="Times New Roman"/>
                  <a:cs typeface="Times New Roman"/>
                </a:rPr>
                <a:t>Isotype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978250" y="3078045"/>
              <a:ext cx="3429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UT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4978250" y="3230451"/>
              <a:ext cx="4090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4995184" y="3382857"/>
              <a:ext cx="9814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CD3 + 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4995184" y="3526796"/>
              <a:ext cx="6335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>
                  <a:latin typeface="Times New Roman"/>
                  <a:cs typeface="Times New Roman"/>
                </a:rPr>
                <a:t>E3CAG1</a:t>
              </a:r>
              <a:endParaRPr lang="en-US" sz="900" b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849595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53</Words>
  <Application>Microsoft Macintosh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ational Institutes of Healt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. I. A. I. D. N. I. H.</dc:creator>
  <cp:lastModifiedBy>N. I. A. I. D. N. I. H.</cp:lastModifiedBy>
  <cp:revision>16</cp:revision>
  <cp:lastPrinted>2012-12-31T16:32:33Z</cp:lastPrinted>
  <dcterms:created xsi:type="dcterms:W3CDTF">2012-08-29T18:03:54Z</dcterms:created>
  <dcterms:modified xsi:type="dcterms:W3CDTF">2012-12-31T17:53:34Z</dcterms:modified>
</cp:coreProperties>
</file>